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71" r:id="rId10"/>
    <p:sldId id="270" r:id="rId11"/>
    <p:sldId id="264" r:id="rId12"/>
    <p:sldId id="265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80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3">
  <dgm:title val=""/>
  <dgm:desc val=""/>
  <dgm:catLst>
    <dgm:cat type="colorful" pri="10300"/>
  </dgm:catLst>
  <dgm:styleLbl name="node0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3"/>
      <a:schemeClr val="accent4"/>
    </dgm:fillClrLst>
    <dgm:linClrLst>
      <a:schemeClr val="accent3"/>
      <a:schemeClr val="accent4"/>
    </dgm:linClrLst>
    <dgm:effectClrLst/>
    <dgm:txLinClrLst/>
    <dgm:txFillClrLst/>
    <dgm:txEffectClrLst/>
  </dgm:styleLbl>
  <dgm:styleLbl name="ln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3">
        <a:alpha val="50000"/>
      </a:schemeClr>
      <a:schemeClr val="accent4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3">
        <a:tint val="50000"/>
      </a:schemeClr>
      <a:schemeClr val="accent4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3"/>
      <a:schemeClr val="accent4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3"/>
    </dgm:fillClrLst>
    <dgm:linClrLst meth="repeat">
      <a:schemeClr val="accent3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3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3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3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colorful3">
  <dgm:title val=""/>
  <dgm:desc val=""/>
  <dgm:catLst>
    <dgm:cat type="colorful" pri="10300"/>
  </dgm:catLst>
  <dgm:styleLbl name="node0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3"/>
      <a:schemeClr val="accent4"/>
    </dgm:fillClrLst>
    <dgm:linClrLst>
      <a:schemeClr val="accent3"/>
      <a:schemeClr val="accent4"/>
    </dgm:linClrLst>
    <dgm:effectClrLst/>
    <dgm:txLinClrLst/>
    <dgm:txFillClrLst/>
    <dgm:txEffectClrLst/>
  </dgm:styleLbl>
  <dgm:styleLbl name="ln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3">
        <a:alpha val="50000"/>
      </a:schemeClr>
      <a:schemeClr val="accent4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3">
        <a:tint val="50000"/>
      </a:schemeClr>
      <a:schemeClr val="accent4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3"/>
      <a:schemeClr val="accent4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3"/>
    </dgm:fillClrLst>
    <dgm:linClrLst meth="repeat">
      <a:schemeClr val="accent3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3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3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3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06E51401-9C46-440A-8808-84DA9758602B}" type="doc">
      <dgm:prSet loTypeId="urn:microsoft.com/office/officeart/2005/8/layout/venn1" loCatId="relationship" qsTypeId="urn:microsoft.com/office/officeart/2005/8/quickstyle/simple1" qsCatId="simple" csTypeId="urn:microsoft.com/office/officeart/2005/8/colors/colorful3" csCatId="colorful" phldr="1"/>
      <dgm:spPr/>
    </dgm:pt>
    <dgm:pt modelId="{2C8E52B1-1725-4270-AEFD-19E1B6B3F3DD}">
      <dgm:prSet phldrT="[Text]" custT="1"/>
      <dgm:spPr>
        <a:solidFill>
          <a:schemeClr val="accent1">
            <a:lumMod val="75000"/>
            <a:alpha val="50000"/>
          </a:schemeClr>
        </a:solidFill>
        <a:ln>
          <a:solidFill>
            <a:schemeClr val="accent1">
              <a:lumMod val="75000"/>
            </a:schemeClr>
          </a:solidFill>
        </a:ln>
      </dgm:spPr>
      <dgm:t>
        <a:bodyPr/>
        <a:lstStyle/>
        <a:p>
          <a:r>
            <a:rPr lang="en-GB" sz="2500" b="1" dirty="0">
              <a:latin typeface="Times New Roman" panose="02020603050405020304" pitchFamily="18" charset="0"/>
              <a:cs typeface="Times New Roman" panose="02020603050405020304" pitchFamily="18" charset="0"/>
            </a:rPr>
            <a:t>18</a:t>
          </a:r>
        </a:p>
      </dgm:t>
    </dgm:pt>
    <dgm:pt modelId="{B0ECCE05-61FC-4E66-901C-3708816AD7F5}" type="parTrans" cxnId="{05770938-2D70-42FC-BD4F-BC914747C8DC}">
      <dgm:prSet/>
      <dgm:spPr/>
      <dgm:t>
        <a:bodyPr/>
        <a:lstStyle/>
        <a:p>
          <a:endParaRPr lang="en-GB" sz="25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0638714-0675-440C-AC88-4F416C304A24}" type="sibTrans" cxnId="{05770938-2D70-42FC-BD4F-BC914747C8DC}">
      <dgm:prSet/>
      <dgm:spPr/>
      <dgm:t>
        <a:bodyPr/>
        <a:lstStyle/>
        <a:p>
          <a:endParaRPr lang="en-GB" sz="25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42382CF-6FB0-43ED-8391-10B2ACE964D5}">
      <dgm:prSet phldrT="[Text]" custT="1"/>
      <dgm:spPr>
        <a:solidFill>
          <a:srgbClr val="C00000">
            <a:alpha val="50000"/>
          </a:srgbClr>
        </a:solidFill>
        <a:ln>
          <a:solidFill>
            <a:srgbClr val="C00000"/>
          </a:solidFill>
        </a:ln>
      </dgm:spPr>
      <dgm:t>
        <a:bodyPr/>
        <a:lstStyle/>
        <a:p>
          <a:r>
            <a:rPr lang="en-GB" sz="2500" b="1" dirty="0">
              <a:latin typeface="Times New Roman" panose="02020603050405020304" pitchFamily="18" charset="0"/>
              <a:cs typeface="Times New Roman" panose="02020603050405020304" pitchFamily="18" charset="0"/>
            </a:rPr>
            <a:t>9</a:t>
          </a:r>
        </a:p>
      </dgm:t>
    </dgm:pt>
    <dgm:pt modelId="{0CF3B9EE-E440-4D5F-9EF3-D9A1BC7B3D55}" type="parTrans" cxnId="{0201B6AE-03A8-4F66-8C6C-1DBCC79A3870}">
      <dgm:prSet/>
      <dgm:spPr/>
      <dgm:t>
        <a:bodyPr/>
        <a:lstStyle/>
        <a:p>
          <a:endParaRPr lang="en-GB" sz="25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5D93866-0BFE-4892-B28C-98BBBD5CF693}" type="sibTrans" cxnId="{0201B6AE-03A8-4F66-8C6C-1DBCC79A3870}">
      <dgm:prSet/>
      <dgm:spPr/>
      <dgm:t>
        <a:bodyPr/>
        <a:lstStyle/>
        <a:p>
          <a:endParaRPr lang="en-GB" sz="25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173C0E0-3C0F-49CE-958C-78566351A178}" type="pres">
      <dgm:prSet presAssocID="{06E51401-9C46-440A-8808-84DA9758602B}" presName="compositeShape" presStyleCnt="0">
        <dgm:presLayoutVars>
          <dgm:chMax val="7"/>
          <dgm:dir/>
          <dgm:resizeHandles val="exact"/>
        </dgm:presLayoutVars>
      </dgm:prSet>
      <dgm:spPr/>
    </dgm:pt>
    <dgm:pt modelId="{E13589F8-EECA-4F9B-9920-1D5424CFFD13}" type="pres">
      <dgm:prSet presAssocID="{2C8E52B1-1725-4270-AEFD-19E1B6B3F3DD}" presName="circ1" presStyleLbl="vennNode1" presStyleIdx="0" presStyleCnt="2" custLinFactNeighborX="-259" custLinFactNeighborY="0"/>
      <dgm:spPr/>
    </dgm:pt>
    <dgm:pt modelId="{7C310979-0737-43EE-B4E3-BBB74D62D7FF}" type="pres">
      <dgm:prSet presAssocID="{2C8E52B1-1725-4270-AEFD-19E1B6B3F3D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A5498179-D73F-475D-85FA-864B966B7D20}" type="pres">
      <dgm:prSet presAssocID="{042382CF-6FB0-43ED-8391-10B2ACE964D5}" presName="circ2" presStyleLbl="vennNode1" presStyleIdx="1" presStyleCnt="2" custScaleX="99517" custLinFactNeighborX="-17558" custLinFactNeighborY="0"/>
      <dgm:spPr/>
    </dgm:pt>
    <dgm:pt modelId="{BF1FBFA7-E0AC-42F4-A27A-FB20D26A68E4}" type="pres">
      <dgm:prSet presAssocID="{042382CF-6FB0-43ED-8391-10B2ACE964D5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99487323-480C-48ED-A8C9-6FB0967F446E}" type="presOf" srcId="{2C8E52B1-1725-4270-AEFD-19E1B6B3F3DD}" destId="{E13589F8-EECA-4F9B-9920-1D5424CFFD13}" srcOrd="0" destOrd="0" presId="urn:microsoft.com/office/officeart/2005/8/layout/venn1"/>
    <dgm:cxn modelId="{05770938-2D70-42FC-BD4F-BC914747C8DC}" srcId="{06E51401-9C46-440A-8808-84DA9758602B}" destId="{2C8E52B1-1725-4270-AEFD-19E1B6B3F3DD}" srcOrd="0" destOrd="0" parTransId="{B0ECCE05-61FC-4E66-901C-3708816AD7F5}" sibTransId="{80638714-0675-440C-AC88-4F416C304A24}"/>
    <dgm:cxn modelId="{4D84C16E-C99C-4A60-B969-C04274360717}" type="presOf" srcId="{06E51401-9C46-440A-8808-84DA9758602B}" destId="{3173C0E0-3C0F-49CE-958C-78566351A178}" srcOrd="0" destOrd="0" presId="urn:microsoft.com/office/officeart/2005/8/layout/venn1"/>
    <dgm:cxn modelId="{B2C6B959-F928-460B-B2C4-D3B5E1EDF22B}" type="presOf" srcId="{042382CF-6FB0-43ED-8391-10B2ACE964D5}" destId="{BF1FBFA7-E0AC-42F4-A27A-FB20D26A68E4}" srcOrd="1" destOrd="0" presId="urn:microsoft.com/office/officeart/2005/8/layout/venn1"/>
    <dgm:cxn modelId="{0201B6AE-03A8-4F66-8C6C-1DBCC79A3870}" srcId="{06E51401-9C46-440A-8808-84DA9758602B}" destId="{042382CF-6FB0-43ED-8391-10B2ACE964D5}" srcOrd="1" destOrd="0" parTransId="{0CF3B9EE-E440-4D5F-9EF3-D9A1BC7B3D55}" sibTransId="{C5D93866-0BFE-4892-B28C-98BBBD5CF693}"/>
    <dgm:cxn modelId="{266504B2-A767-4146-8F0A-9F5C53F49965}" type="presOf" srcId="{2C8E52B1-1725-4270-AEFD-19E1B6B3F3DD}" destId="{7C310979-0737-43EE-B4E3-BBB74D62D7FF}" srcOrd="1" destOrd="0" presId="urn:microsoft.com/office/officeart/2005/8/layout/venn1"/>
    <dgm:cxn modelId="{7058FCBF-19D2-4208-8E35-D08A991E675A}" type="presOf" srcId="{042382CF-6FB0-43ED-8391-10B2ACE964D5}" destId="{A5498179-D73F-475D-85FA-864B966B7D20}" srcOrd="0" destOrd="0" presId="urn:microsoft.com/office/officeart/2005/8/layout/venn1"/>
    <dgm:cxn modelId="{783F3755-C110-432D-BF36-41831A3D1E7C}" type="presParOf" srcId="{3173C0E0-3C0F-49CE-958C-78566351A178}" destId="{E13589F8-EECA-4F9B-9920-1D5424CFFD13}" srcOrd="0" destOrd="0" presId="urn:microsoft.com/office/officeart/2005/8/layout/venn1"/>
    <dgm:cxn modelId="{5193C55C-9ADF-4705-9390-A7A36DE6A174}" type="presParOf" srcId="{3173C0E0-3C0F-49CE-958C-78566351A178}" destId="{7C310979-0737-43EE-B4E3-BBB74D62D7FF}" srcOrd="1" destOrd="0" presId="urn:microsoft.com/office/officeart/2005/8/layout/venn1"/>
    <dgm:cxn modelId="{3630DB3D-35C5-4B2F-802C-E1E95F13010E}" type="presParOf" srcId="{3173C0E0-3C0F-49CE-958C-78566351A178}" destId="{A5498179-D73F-475D-85FA-864B966B7D20}" srcOrd="2" destOrd="0" presId="urn:microsoft.com/office/officeart/2005/8/layout/venn1"/>
    <dgm:cxn modelId="{97EB90FB-BF59-47AC-A0E8-E5689256B4A9}" type="presParOf" srcId="{3173C0E0-3C0F-49CE-958C-78566351A178}" destId="{BF1FBFA7-E0AC-42F4-A27A-FB20D26A68E4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06E51401-9C46-440A-8808-84DA9758602B}" type="doc">
      <dgm:prSet loTypeId="urn:microsoft.com/office/officeart/2005/8/layout/venn1" loCatId="relationship" qsTypeId="urn:microsoft.com/office/officeart/2005/8/quickstyle/simple1" qsCatId="simple" csTypeId="urn:microsoft.com/office/officeart/2005/8/colors/colorful3" csCatId="colorful" phldr="1"/>
      <dgm:spPr/>
    </dgm:pt>
    <dgm:pt modelId="{2C8E52B1-1725-4270-AEFD-19E1B6B3F3DD}">
      <dgm:prSet phldrT="[Text]" custT="1"/>
      <dgm:spPr>
        <a:solidFill>
          <a:schemeClr val="accent1">
            <a:lumMod val="75000"/>
            <a:alpha val="50000"/>
          </a:schemeClr>
        </a:solidFill>
        <a:ln>
          <a:solidFill>
            <a:schemeClr val="accent1">
              <a:lumMod val="75000"/>
            </a:schemeClr>
          </a:solidFill>
        </a:ln>
      </dgm:spPr>
      <dgm:t>
        <a:bodyPr/>
        <a:lstStyle/>
        <a:p>
          <a:r>
            <a:rPr lang="en-GB" sz="2500" b="1" dirty="0">
              <a:latin typeface="Times New Roman" panose="02020603050405020304" pitchFamily="18" charset="0"/>
              <a:cs typeface="Times New Roman" panose="02020603050405020304" pitchFamily="18" charset="0"/>
            </a:rPr>
            <a:t>15</a:t>
          </a:r>
        </a:p>
      </dgm:t>
    </dgm:pt>
    <dgm:pt modelId="{B0ECCE05-61FC-4E66-901C-3708816AD7F5}" type="parTrans" cxnId="{05770938-2D70-42FC-BD4F-BC914747C8DC}">
      <dgm:prSet/>
      <dgm:spPr/>
      <dgm:t>
        <a:bodyPr/>
        <a:lstStyle/>
        <a:p>
          <a:endParaRPr lang="en-GB" sz="25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0638714-0675-440C-AC88-4F416C304A24}" type="sibTrans" cxnId="{05770938-2D70-42FC-BD4F-BC914747C8DC}">
      <dgm:prSet/>
      <dgm:spPr/>
      <dgm:t>
        <a:bodyPr/>
        <a:lstStyle/>
        <a:p>
          <a:endParaRPr lang="en-GB" sz="25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42382CF-6FB0-43ED-8391-10B2ACE964D5}">
      <dgm:prSet phldrT="[Text]" custT="1"/>
      <dgm:spPr>
        <a:solidFill>
          <a:srgbClr val="C00000">
            <a:alpha val="50000"/>
          </a:srgbClr>
        </a:solidFill>
        <a:ln>
          <a:solidFill>
            <a:srgbClr val="C00000"/>
          </a:solidFill>
        </a:ln>
      </dgm:spPr>
      <dgm:t>
        <a:bodyPr/>
        <a:lstStyle/>
        <a:p>
          <a:r>
            <a:rPr lang="en-GB" sz="2500" b="1" dirty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</a:p>
      </dgm:t>
    </dgm:pt>
    <dgm:pt modelId="{0CF3B9EE-E440-4D5F-9EF3-D9A1BC7B3D55}" type="parTrans" cxnId="{0201B6AE-03A8-4F66-8C6C-1DBCC79A3870}">
      <dgm:prSet/>
      <dgm:spPr/>
      <dgm:t>
        <a:bodyPr/>
        <a:lstStyle/>
        <a:p>
          <a:endParaRPr lang="en-GB" sz="25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5D93866-0BFE-4892-B28C-98BBBD5CF693}" type="sibTrans" cxnId="{0201B6AE-03A8-4F66-8C6C-1DBCC79A3870}">
      <dgm:prSet/>
      <dgm:spPr/>
      <dgm:t>
        <a:bodyPr/>
        <a:lstStyle/>
        <a:p>
          <a:endParaRPr lang="en-GB" sz="25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173C0E0-3C0F-49CE-958C-78566351A178}" type="pres">
      <dgm:prSet presAssocID="{06E51401-9C46-440A-8808-84DA9758602B}" presName="compositeShape" presStyleCnt="0">
        <dgm:presLayoutVars>
          <dgm:chMax val="7"/>
          <dgm:dir/>
          <dgm:resizeHandles val="exact"/>
        </dgm:presLayoutVars>
      </dgm:prSet>
      <dgm:spPr/>
    </dgm:pt>
    <dgm:pt modelId="{E13589F8-EECA-4F9B-9920-1D5424CFFD13}" type="pres">
      <dgm:prSet presAssocID="{2C8E52B1-1725-4270-AEFD-19E1B6B3F3DD}" presName="circ1" presStyleLbl="vennNode1" presStyleIdx="0" presStyleCnt="2" custLinFactNeighborX="-259" custLinFactNeighborY="0"/>
      <dgm:spPr/>
    </dgm:pt>
    <dgm:pt modelId="{7C310979-0737-43EE-B4E3-BBB74D62D7FF}" type="pres">
      <dgm:prSet presAssocID="{2C8E52B1-1725-4270-AEFD-19E1B6B3F3D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A5498179-D73F-475D-85FA-864B966B7D20}" type="pres">
      <dgm:prSet presAssocID="{042382CF-6FB0-43ED-8391-10B2ACE964D5}" presName="circ2" presStyleLbl="vennNode1" presStyleIdx="1" presStyleCnt="2" custScaleX="99517" custLinFactNeighborX="-17558" custLinFactNeighborY="0"/>
      <dgm:spPr/>
    </dgm:pt>
    <dgm:pt modelId="{BF1FBFA7-E0AC-42F4-A27A-FB20D26A68E4}" type="pres">
      <dgm:prSet presAssocID="{042382CF-6FB0-43ED-8391-10B2ACE964D5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99487323-480C-48ED-A8C9-6FB0967F446E}" type="presOf" srcId="{2C8E52B1-1725-4270-AEFD-19E1B6B3F3DD}" destId="{E13589F8-EECA-4F9B-9920-1D5424CFFD13}" srcOrd="0" destOrd="0" presId="urn:microsoft.com/office/officeart/2005/8/layout/venn1"/>
    <dgm:cxn modelId="{05770938-2D70-42FC-BD4F-BC914747C8DC}" srcId="{06E51401-9C46-440A-8808-84DA9758602B}" destId="{2C8E52B1-1725-4270-AEFD-19E1B6B3F3DD}" srcOrd="0" destOrd="0" parTransId="{B0ECCE05-61FC-4E66-901C-3708816AD7F5}" sibTransId="{80638714-0675-440C-AC88-4F416C304A24}"/>
    <dgm:cxn modelId="{4D84C16E-C99C-4A60-B969-C04274360717}" type="presOf" srcId="{06E51401-9C46-440A-8808-84DA9758602B}" destId="{3173C0E0-3C0F-49CE-958C-78566351A178}" srcOrd="0" destOrd="0" presId="urn:microsoft.com/office/officeart/2005/8/layout/venn1"/>
    <dgm:cxn modelId="{B2C6B959-F928-460B-B2C4-D3B5E1EDF22B}" type="presOf" srcId="{042382CF-6FB0-43ED-8391-10B2ACE964D5}" destId="{BF1FBFA7-E0AC-42F4-A27A-FB20D26A68E4}" srcOrd="1" destOrd="0" presId="urn:microsoft.com/office/officeart/2005/8/layout/venn1"/>
    <dgm:cxn modelId="{0201B6AE-03A8-4F66-8C6C-1DBCC79A3870}" srcId="{06E51401-9C46-440A-8808-84DA9758602B}" destId="{042382CF-6FB0-43ED-8391-10B2ACE964D5}" srcOrd="1" destOrd="0" parTransId="{0CF3B9EE-E440-4D5F-9EF3-D9A1BC7B3D55}" sibTransId="{C5D93866-0BFE-4892-B28C-98BBBD5CF693}"/>
    <dgm:cxn modelId="{266504B2-A767-4146-8F0A-9F5C53F49965}" type="presOf" srcId="{2C8E52B1-1725-4270-AEFD-19E1B6B3F3DD}" destId="{7C310979-0737-43EE-B4E3-BBB74D62D7FF}" srcOrd="1" destOrd="0" presId="urn:microsoft.com/office/officeart/2005/8/layout/venn1"/>
    <dgm:cxn modelId="{7058FCBF-19D2-4208-8E35-D08A991E675A}" type="presOf" srcId="{042382CF-6FB0-43ED-8391-10B2ACE964D5}" destId="{A5498179-D73F-475D-85FA-864B966B7D20}" srcOrd="0" destOrd="0" presId="urn:microsoft.com/office/officeart/2005/8/layout/venn1"/>
    <dgm:cxn modelId="{783F3755-C110-432D-BF36-41831A3D1E7C}" type="presParOf" srcId="{3173C0E0-3C0F-49CE-958C-78566351A178}" destId="{E13589F8-EECA-4F9B-9920-1D5424CFFD13}" srcOrd="0" destOrd="0" presId="urn:microsoft.com/office/officeart/2005/8/layout/venn1"/>
    <dgm:cxn modelId="{5193C55C-9ADF-4705-9390-A7A36DE6A174}" type="presParOf" srcId="{3173C0E0-3C0F-49CE-958C-78566351A178}" destId="{7C310979-0737-43EE-B4E3-BBB74D62D7FF}" srcOrd="1" destOrd="0" presId="urn:microsoft.com/office/officeart/2005/8/layout/venn1"/>
    <dgm:cxn modelId="{3630DB3D-35C5-4B2F-802C-E1E95F13010E}" type="presParOf" srcId="{3173C0E0-3C0F-49CE-958C-78566351A178}" destId="{A5498179-D73F-475D-85FA-864B966B7D20}" srcOrd="2" destOrd="0" presId="urn:microsoft.com/office/officeart/2005/8/layout/venn1"/>
    <dgm:cxn modelId="{97EB90FB-BF59-47AC-A0E8-E5689256B4A9}" type="presParOf" srcId="{3173C0E0-3C0F-49CE-958C-78566351A178}" destId="{BF1FBFA7-E0AC-42F4-A27A-FB20D26A68E4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E13589F8-EECA-4F9B-9920-1D5424CFFD13}">
      <dsp:nvSpPr>
        <dsp:cNvPr id="0" name=""/>
        <dsp:cNvSpPr/>
      </dsp:nvSpPr>
      <dsp:spPr>
        <a:xfrm>
          <a:off x="114598" y="505310"/>
          <a:ext cx="2926554" cy="2926554"/>
        </a:xfrm>
        <a:prstGeom prst="ellipse">
          <a:avLst/>
        </a:prstGeom>
        <a:solidFill>
          <a:schemeClr val="accent1">
            <a:lumMod val="75000"/>
            <a:alpha val="50000"/>
          </a:schemeClr>
        </a:solidFill>
        <a:ln w="12700" cap="flat" cmpd="sng" algn="ctr">
          <a:solidFill>
            <a:schemeClr val="accent1">
              <a:lumMod val="75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5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18</a:t>
          </a:r>
        </a:p>
      </dsp:txBody>
      <dsp:txXfrm>
        <a:off x="523261" y="850413"/>
        <a:ext cx="1687382" cy="2236347"/>
      </dsp:txXfrm>
    </dsp:sp>
    <dsp:sp modelId="{A5498179-D73F-475D-85FA-864B966B7D20}">
      <dsp:nvSpPr>
        <dsp:cNvPr id="0" name=""/>
        <dsp:cNvSpPr/>
      </dsp:nvSpPr>
      <dsp:spPr>
        <a:xfrm>
          <a:off x="1724629" y="505310"/>
          <a:ext cx="2912419" cy="2926554"/>
        </a:xfrm>
        <a:prstGeom prst="ellipse">
          <a:avLst/>
        </a:prstGeom>
        <a:solidFill>
          <a:srgbClr val="C00000">
            <a:alpha val="50000"/>
          </a:srgbClr>
        </a:solidFill>
        <a:ln w="12700" cap="flat" cmpd="sng" algn="ctr">
          <a:solidFill>
            <a:srgbClr val="C0000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5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9</a:t>
          </a:r>
        </a:p>
      </dsp:txBody>
      <dsp:txXfrm>
        <a:off x="2551126" y="850413"/>
        <a:ext cx="1679232" cy="2236347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E13589F8-EECA-4F9B-9920-1D5424CFFD13}">
      <dsp:nvSpPr>
        <dsp:cNvPr id="0" name=""/>
        <dsp:cNvSpPr/>
      </dsp:nvSpPr>
      <dsp:spPr>
        <a:xfrm>
          <a:off x="114598" y="505310"/>
          <a:ext cx="2926554" cy="2926554"/>
        </a:xfrm>
        <a:prstGeom prst="ellipse">
          <a:avLst/>
        </a:prstGeom>
        <a:solidFill>
          <a:schemeClr val="accent1">
            <a:lumMod val="75000"/>
            <a:alpha val="50000"/>
          </a:schemeClr>
        </a:solidFill>
        <a:ln w="12700" cap="flat" cmpd="sng" algn="ctr">
          <a:solidFill>
            <a:schemeClr val="accent1">
              <a:lumMod val="75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5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15</a:t>
          </a:r>
        </a:p>
      </dsp:txBody>
      <dsp:txXfrm>
        <a:off x="523261" y="850413"/>
        <a:ext cx="1687382" cy="2236347"/>
      </dsp:txXfrm>
    </dsp:sp>
    <dsp:sp modelId="{A5498179-D73F-475D-85FA-864B966B7D20}">
      <dsp:nvSpPr>
        <dsp:cNvPr id="0" name=""/>
        <dsp:cNvSpPr/>
      </dsp:nvSpPr>
      <dsp:spPr>
        <a:xfrm>
          <a:off x="1724629" y="505310"/>
          <a:ext cx="2912419" cy="2926554"/>
        </a:xfrm>
        <a:prstGeom prst="ellipse">
          <a:avLst/>
        </a:prstGeom>
        <a:solidFill>
          <a:srgbClr val="C00000">
            <a:alpha val="50000"/>
          </a:srgbClr>
        </a:solidFill>
        <a:ln w="12700" cap="flat" cmpd="sng" algn="ctr">
          <a:solidFill>
            <a:srgbClr val="C0000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5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</a:p>
      </dsp:txBody>
      <dsp:txXfrm>
        <a:off x="2551126" y="850413"/>
        <a:ext cx="1679232" cy="223634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B82E48-0D25-4738-AF64-B9E6974F2FA9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2C1D65-3D2C-4E96-A9D1-CF0A45DAC2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6141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7F470-D265-4B30-8476-FA764DB8E9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BA6685-77FE-4DB1-9206-0792BA8889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3BB416-9DE9-4194-8E68-BFC57C0A2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EC642D-F44E-4B81-9F14-5BD10D264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AD36A0-7606-47A0-8459-89CA34C6A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4337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94E057-CE17-491F-B553-426B121DC5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7BEEFD-CAFE-46F9-B927-E60B124F6E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4F9110-0CA5-4E09-B3BB-292408ECB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92935B-F4AA-43F2-ABE4-B4BA3E0A4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DBBF92-FC73-4966-AA29-000163688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9579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F75A68-C359-457D-A257-E61692A05E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E8B077-658D-4744-BD23-8B190091B4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2C09A3-1359-4F98-A64A-41476FFEE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5B0F67-C59D-4252-9049-81D00B8E0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50340D-E0F1-4D50-8F91-030B8C6E8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076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AEB096-593E-4F5B-A28E-F056DE8834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692AC6-03E4-4059-B688-4F02C1BD4C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385570-68D1-4398-BBC3-672D9AF13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FB1795-0F81-4FFB-9B79-84464D10E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D8931D-BDFD-4D17-B261-17C445F64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4950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60FF43-E993-4A38-9F04-D9F4E6AA0C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CE9CCF-6E39-4138-9183-80FB7147AF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0EB096-80DA-4F54-B22E-A286EE3E7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D10311-A997-44D5-94CC-9F33E37E3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7B8A68-4B05-4106-B1D0-01F887BE2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481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59DC52-EE78-43A0-BC31-66B35514C5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C4456E-039F-49BD-8804-AAA9D164DF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487DCA-6258-4EA3-98F7-D766E7986F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50E5AE-5EBB-4A37-82A0-6930EBED7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93936F-40FE-41CD-8019-40B35E274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A9E315-F7BC-4780-AFEE-61D3489F5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3532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CDFF96-05C6-4615-8AD5-2655F8C42F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21D26F-5177-465E-876E-84D7E1FC8B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B15860-64B6-48BD-8A1F-CDACE818B7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01ED7A-195D-4236-B137-6E2B88E79B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5A5EAE-B166-48C4-A41B-CF3ED2C618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6BC96ED-8E3B-422B-9DA9-8E523E312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7DDE3B-A7DF-49F8-9E62-084C990D9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BAD03C-BB31-4497-B660-7D37C9D2A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382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4DB9B-9A59-4EC5-8BF5-04D4C890F0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81E647-C8B5-4A10-B9D9-7A069B548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04C560E-D06F-4C6A-B5BB-A0FB793B2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2C962B-9B61-49BF-A6FC-B813E0E36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564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42AB79-72B3-416D-9B00-74B3B064A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B79D418-977E-4131-9CF5-93EBE088A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932053-6358-4B00-8729-F464F3CA9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3194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C97C95-B76A-4B95-A249-55BAAB01C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1AB039-DE64-4F2A-AF6A-0CEFB9BCB1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4A55CF-0EED-4456-A947-599CF9B0FF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AC6E5D-CE12-44B2-B678-8A5E223DB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5CE484-5899-4BF1-99E2-94095134A9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4970EB-5F66-460A-9F90-AD43C7C90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6379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04EAAF-D4F5-41D4-BCE6-B7A56F6D62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EE8369-1828-41DB-95A1-AFE28DD684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5718FB-31BB-4E83-A946-0B67D6FC6A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49B013-DF56-49CE-BDBF-E507D3D20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AA7D80-67CE-475A-8E8B-3E9AE4ABA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F5BF04-28A8-40C7-9C9C-F060A1CD7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0646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D741BC7-90DD-43BF-AFD8-DD56B3ABCF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E1CE4D-96AB-40B3-A98C-BCE6DD4953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2C8C1E-5AF7-4B74-AD03-1344094CC6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170B8-DA84-4581-AD76-6914A3BF545B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517DBD-30C7-45DE-BE69-44E802EFDE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AACB45-85E3-44D8-89D6-F2BA452EF9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8370B7-5E8B-4763-83B4-D4D70428DF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7364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blpatil2046@gmail.com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sv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638D6238-FB35-6664-27A0-D3636703C4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715617"/>
            <a:ext cx="9144000" cy="785192"/>
          </a:xfrm>
        </p:spPr>
        <p:txBody>
          <a:bodyPr>
            <a:normAutofit fontScale="90000"/>
          </a:bodyPr>
          <a:lstStyle/>
          <a:p>
            <a:r>
              <a:rPr lang="en-GB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</a:rPr>
              <a:t>Supplementary Data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3252E2D-5D52-DD1A-B755-9DA082E4BE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665922" y="1974953"/>
            <a:ext cx="11012556" cy="3640655"/>
          </a:xfrm>
        </p:spPr>
        <p:txBody>
          <a:bodyPr>
            <a:no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GB" b="1" dirty="0">
                <a:effectLst/>
                <a:ea typeface="Times New Roman" panose="02020603050405020304" pitchFamily="18" charset="0"/>
              </a:rPr>
              <a:t>Differential expression of microRNAs in response to </a:t>
            </a:r>
            <a:r>
              <a:rPr lang="en-GB" b="1" i="1" dirty="0">
                <a:effectLst/>
                <a:ea typeface="Times New Roman" panose="02020603050405020304" pitchFamily="18" charset="0"/>
              </a:rPr>
              <a:t>Papaya ringspot virus</a:t>
            </a:r>
            <a:r>
              <a:rPr lang="en-GB" b="1" dirty="0">
                <a:effectLst/>
                <a:ea typeface="Times New Roman" panose="02020603050405020304" pitchFamily="18" charset="0"/>
              </a:rPr>
              <a:t> infection in differentially responding genotypes of Papaya (</a:t>
            </a:r>
            <a:r>
              <a:rPr lang="en-GB" b="1" i="1" dirty="0" err="1">
                <a:effectLst/>
                <a:ea typeface="Times New Roman" panose="02020603050405020304" pitchFamily="18" charset="0"/>
              </a:rPr>
              <a:t>Carica</a:t>
            </a:r>
            <a:r>
              <a:rPr lang="en-GB" b="1" i="1" dirty="0">
                <a:effectLst/>
                <a:ea typeface="Times New Roman" panose="02020603050405020304" pitchFamily="18" charset="0"/>
              </a:rPr>
              <a:t> papaya</a:t>
            </a:r>
            <a:r>
              <a:rPr lang="en-GB" b="1" dirty="0">
                <a:effectLst/>
                <a:ea typeface="Times New Roman" panose="02020603050405020304" pitchFamily="18" charset="0"/>
              </a:rPr>
              <a:t> L.) and its wild relative</a:t>
            </a:r>
            <a:endParaRPr lang="en-IN" dirty="0">
              <a:effectLst/>
              <a:ea typeface="Calibri" panose="020F0502020204030204" pitchFamily="34" charset="0"/>
            </a:endParaRPr>
          </a:p>
          <a:p>
            <a:pPr marL="115570" indent="-115570" algn="just">
              <a:lnSpc>
                <a:spcPct val="150000"/>
              </a:lnSpc>
              <a:spcAft>
                <a:spcPts val="60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asavaprabhu L. Patil</a:t>
            </a:r>
            <a:r>
              <a:rPr lang="en-US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*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and </a:t>
            </a:r>
            <a:r>
              <a:rPr lang="en-US" sz="18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avarni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Tripathi</a:t>
            </a:r>
            <a:r>
              <a:rPr lang="en-US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2</a:t>
            </a:r>
            <a:endParaRPr lang="en-IN" sz="1800" dirty="0">
              <a:effectLst/>
              <a:ea typeface="Calibri" panose="020F0502020204030204" pitchFamily="34" charset="0"/>
            </a:endParaRPr>
          </a:p>
          <a:p>
            <a:pPr marL="115570" indent="-115570" algn="just">
              <a:lnSpc>
                <a:spcPct val="150000"/>
              </a:lnSpc>
              <a:spcAft>
                <a:spcPts val="600"/>
              </a:spcAft>
            </a:pPr>
            <a:r>
              <a:rPr lang="en-US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ICAR-Indian Institute of Horticultural Research, Bengaluru-560089, India</a:t>
            </a:r>
            <a:endParaRPr lang="en-IN" sz="1800" dirty="0">
              <a:effectLst/>
              <a:ea typeface="Calibri" panose="020F0502020204030204" pitchFamily="34" charset="0"/>
            </a:endParaRP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GB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2</a:t>
            </a:r>
            <a:r>
              <a:rPr lang="en-GB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ICAR-Indian Agricultural Research Institute, Regional Station, Pune-411067, India</a:t>
            </a:r>
            <a:r>
              <a:rPr lang="en-GB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  <a:endParaRPr lang="en-IN" sz="1800" dirty="0">
              <a:effectLst/>
              <a:ea typeface="Calibri" panose="020F0502020204030204" pitchFamily="34" charset="0"/>
            </a:endParaRP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GB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*</a:t>
            </a:r>
            <a:r>
              <a:rPr lang="en-GB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orresponding author E-mail: </a:t>
            </a:r>
            <a:r>
              <a:rPr lang="en-GB" sz="1800" u="sng" dirty="0">
                <a:solidFill>
                  <a:srgbClr val="0000FF"/>
                </a:solidFill>
                <a:effectLst/>
                <a:ea typeface="Times New Roman" panose="02020603050405020304" pitchFamily="18" charset="0"/>
                <a:hlinkClick r:id="rId2"/>
              </a:rPr>
              <a:t>blpatil2046@gmail.com</a:t>
            </a:r>
            <a:r>
              <a:rPr lang="en-GB" sz="1800" u="sng" dirty="0">
                <a:solidFill>
                  <a:srgbClr val="0000FF"/>
                </a:solidFill>
                <a:effectLst/>
                <a:ea typeface="Times New Roman" panose="02020603050405020304" pitchFamily="18" charset="0"/>
              </a:rPr>
              <a:t>, Basavaprabhu.Patil@icar.gov.in</a:t>
            </a:r>
            <a:r>
              <a:rPr lang="en-GB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  <a:endParaRPr lang="en-IN" sz="1800" dirty="0">
              <a:effectLst/>
              <a:ea typeface="Calibri" panose="020F0502020204030204" pitchFamily="34" charset="0"/>
            </a:endParaRPr>
          </a:p>
          <a:p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4159771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502E0F34-9038-4C2A-B056-6C548774097B}"/>
              </a:ext>
            </a:extLst>
          </p:cNvPr>
          <p:cNvGrpSpPr/>
          <p:nvPr/>
        </p:nvGrpSpPr>
        <p:grpSpPr>
          <a:xfrm>
            <a:off x="2158739" y="1209860"/>
            <a:ext cx="6862174" cy="3937175"/>
            <a:chOff x="2158739" y="1209860"/>
            <a:chExt cx="6862174" cy="3937175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70C8F1E7-3D5A-428B-8AC3-DEC3480AC443}"/>
                </a:ext>
              </a:extLst>
            </p:cNvPr>
            <p:cNvGrpSpPr/>
            <p:nvPr/>
          </p:nvGrpSpPr>
          <p:grpSpPr>
            <a:xfrm>
              <a:off x="2691629" y="1209860"/>
              <a:ext cx="6329284" cy="3937175"/>
              <a:chOff x="1150989" y="719666"/>
              <a:chExt cx="7880284" cy="5418667"/>
            </a:xfrm>
          </p:grpSpPr>
          <p:graphicFrame>
            <p:nvGraphicFramePr>
              <p:cNvPr id="2" name="Diagram 1">
                <a:extLst>
                  <a:ext uri="{FF2B5EF4-FFF2-40B4-BE49-F238E27FC236}">
                    <a16:creationId xmlns:a16="http://schemas.microsoft.com/office/drawing/2014/main" id="{D50BA3A3-1B29-431F-878E-3CE8B3F4E49B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366653236"/>
                  </p:ext>
                </p:extLst>
              </p:nvPr>
            </p:nvGraphicFramePr>
            <p:xfrm>
              <a:off x="2032000" y="719666"/>
              <a:ext cx="6565245" cy="5418667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2" r:lo="rId3" r:qs="rId4" r:cs="rId5"/>
              </a:graphicData>
            </a:graphic>
          </p:graphicFrame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95E110A7-7E02-4EE6-8A37-E85640B8953D}"/>
                  </a:ext>
                </a:extLst>
              </p:cNvPr>
              <p:cNvSpPr txBox="1"/>
              <p:nvPr/>
            </p:nvSpPr>
            <p:spPr>
              <a:xfrm>
                <a:off x="4694549" y="3167407"/>
                <a:ext cx="505267" cy="4770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2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9</a:t>
                </a:r>
              </a:p>
            </p:txBody>
          </p:sp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389A9CDC-17F0-47FD-B08F-D0A5DCE7F9F5}"/>
                  </a:ext>
                </a:extLst>
              </p:cNvPr>
              <p:cNvSpPr/>
              <p:nvPr/>
            </p:nvSpPr>
            <p:spPr>
              <a:xfrm>
                <a:off x="1150989" y="1154691"/>
                <a:ext cx="176202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M- I vs PM-H</a:t>
                </a:r>
                <a:r>
                  <a:rPr lang="en-GB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3C620EB7-CFF8-4BAA-8FDF-047F1B240B86}"/>
                  </a:ext>
                </a:extLst>
              </p:cNvPr>
              <p:cNvSpPr/>
              <p:nvPr/>
            </p:nvSpPr>
            <p:spPr>
              <a:xfrm>
                <a:off x="7275664" y="4705488"/>
                <a:ext cx="1755609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3-I vs PS3-H</a:t>
                </a:r>
                <a:r>
                  <a:rPr lang="en-GB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CD0A443-36C0-4F0C-A215-EEED33FB9599}"/>
                </a:ext>
              </a:extLst>
            </p:cNvPr>
            <p:cNvSpPr txBox="1"/>
            <p:nvPr/>
          </p:nvSpPr>
          <p:spPr>
            <a:xfrm>
              <a:off x="2158739" y="1209860"/>
              <a:ext cx="7767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584271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965E678-9E4C-41FA-BD24-8789FC4411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6650" y="1581150"/>
            <a:ext cx="4838700" cy="36957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0021626-4185-4BE4-A514-6F46206A0E19}"/>
              </a:ext>
            </a:extLst>
          </p:cNvPr>
          <p:cNvSpPr txBox="1"/>
          <p:nvPr/>
        </p:nvSpPr>
        <p:spPr>
          <a:xfrm>
            <a:off x="7975076" y="1291472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RNA</a:t>
            </a:r>
          </a:p>
        </p:txBody>
      </p:sp>
    </p:spTree>
    <p:extLst>
      <p:ext uri="{BB962C8B-B14F-4D97-AF65-F5344CB8AC3E}">
        <p14:creationId xmlns:p14="http://schemas.microsoft.com/office/powerpoint/2010/main" val="1378114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CAFE211-7D6B-495B-A57A-E60E2B591E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300" y="1590675"/>
            <a:ext cx="5105400" cy="36766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2F57F15-85F7-478F-BFD5-B552F3F7AE95}"/>
              </a:ext>
            </a:extLst>
          </p:cNvPr>
          <p:cNvSpPr txBox="1"/>
          <p:nvPr/>
        </p:nvSpPr>
        <p:spPr>
          <a:xfrm>
            <a:off x="7975076" y="1291472"/>
            <a:ext cx="1151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mall RNA</a:t>
            </a:r>
          </a:p>
        </p:txBody>
      </p:sp>
    </p:spTree>
    <p:extLst>
      <p:ext uri="{BB962C8B-B14F-4D97-AF65-F5344CB8AC3E}">
        <p14:creationId xmlns:p14="http://schemas.microsoft.com/office/powerpoint/2010/main" val="21328321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">
            <a:extLst>
              <a:ext uri="{FF2B5EF4-FFF2-40B4-BE49-F238E27FC236}">
                <a16:creationId xmlns:a16="http://schemas.microsoft.com/office/drawing/2014/main" id="{822F38CB-86A0-4266-9D80-685D18C469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476626" y="1096307"/>
            <a:ext cx="5667375" cy="540067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28D524D-78EB-4399-A9B0-6F68B7F7CF0B}"/>
              </a:ext>
            </a:extLst>
          </p:cNvPr>
          <p:cNvSpPr/>
          <p:nvPr/>
        </p:nvSpPr>
        <p:spPr>
          <a:xfrm>
            <a:off x="2691991" y="176352"/>
            <a:ext cx="781889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PM-IvsPM-H-PM-IvsPS3-H-PM-IvsVC-PS3-H_vs_PM-H-PS3-I_vs_PM-I </a:t>
            </a:r>
            <a:r>
              <a:rPr lang="en-GB" b="1" dirty="0" err="1"/>
              <a:t>kmiRNA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617187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">
            <a:extLst>
              <a:ext uri="{FF2B5EF4-FFF2-40B4-BE49-F238E27FC236}">
                <a16:creationId xmlns:a16="http://schemas.microsoft.com/office/drawing/2014/main" id="{DDC0FC11-0155-4BDB-8355-03435E8553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262311" y="543996"/>
            <a:ext cx="5667375" cy="540067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6E8B8241-27B4-4956-94FF-5ED104752805}"/>
              </a:ext>
            </a:extLst>
          </p:cNvPr>
          <p:cNvSpPr/>
          <p:nvPr/>
        </p:nvSpPr>
        <p:spPr>
          <a:xfrm>
            <a:off x="2271483" y="97067"/>
            <a:ext cx="69474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VCvsPS3-H_PS3-IvsPM-H_PS3-IvsPS3-H_PS3-IvsVC_VCvsPM-H  </a:t>
            </a:r>
            <a:r>
              <a:rPr lang="en-GB" b="1" dirty="0" err="1"/>
              <a:t>kmiRNA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3805842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">
            <a:extLst>
              <a:ext uri="{FF2B5EF4-FFF2-40B4-BE49-F238E27FC236}">
                <a16:creationId xmlns:a16="http://schemas.microsoft.com/office/drawing/2014/main" id="{DB3860ED-80E7-4782-96BF-E0EAA97130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262312" y="728662"/>
            <a:ext cx="5667375" cy="540067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423880D2-03D1-4EF2-B54F-5CE1C4FA3097}"/>
              </a:ext>
            </a:extLst>
          </p:cNvPr>
          <p:cNvSpPr/>
          <p:nvPr/>
        </p:nvSpPr>
        <p:spPr>
          <a:xfrm>
            <a:off x="1926209" y="89258"/>
            <a:ext cx="86248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PM-IvsPM-H_PM-IvsPS3-H_PS3-HvsPM-H_PS3-IvsPM-H_PS3-IvsPM-I mRNA </a:t>
            </a:r>
          </a:p>
        </p:txBody>
      </p:sp>
    </p:spTree>
    <p:extLst>
      <p:ext uri="{BB962C8B-B14F-4D97-AF65-F5344CB8AC3E}">
        <p14:creationId xmlns:p14="http://schemas.microsoft.com/office/powerpoint/2010/main" val="34103632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">
            <a:extLst>
              <a:ext uri="{FF2B5EF4-FFF2-40B4-BE49-F238E27FC236}">
                <a16:creationId xmlns:a16="http://schemas.microsoft.com/office/drawing/2014/main" id="{ED5D9037-1687-4843-8922-C374537CFA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262312" y="728662"/>
            <a:ext cx="5667375" cy="540067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A63D7070-7C9F-4CA0-90B9-530846D2237D}"/>
              </a:ext>
            </a:extLst>
          </p:cNvPr>
          <p:cNvSpPr/>
          <p:nvPr/>
        </p:nvSpPr>
        <p:spPr>
          <a:xfrm>
            <a:off x="2963159" y="108112"/>
            <a:ext cx="787766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PM-IvsPS3-H_PS3-HvsPM-H_PS3-IvsPM-H_PS3-IvsPM-I_PS3-IvsPS3-H  mRNA</a:t>
            </a:r>
          </a:p>
        </p:txBody>
      </p:sp>
    </p:spTree>
    <p:extLst>
      <p:ext uri="{BB962C8B-B14F-4D97-AF65-F5344CB8AC3E}">
        <p14:creationId xmlns:p14="http://schemas.microsoft.com/office/powerpoint/2010/main" val="4183873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">
            <a:extLst>
              <a:ext uri="{FF2B5EF4-FFF2-40B4-BE49-F238E27FC236}">
                <a16:creationId xmlns:a16="http://schemas.microsoft.com/office/drawing/2014/main" id="{B3D7DE19-E984-44F8-AFE1-FDA3627885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262312" y="728662"/>
            <a:ext cx="5667375" cy="540067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B31F3732-AF12-436C-9052-A1397313E8FA}"/>
              </a:ext>
            </a:extLst>
          </p:cNvPr>
          <p:cNvSpPr/>
          <p:nvPr/>
        </p:nvSpPr>
        <p:spPr>
          <a:xfrm>
            <a:off x="1370029" y="296135"/>
            <a:ext cx="87260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PM-IvsPM-H_PM-IvsPS3-H_PM-IvsVC_PS3-HvsPM-H_PS3-IvsPM-H novel miRNA</a:t>
            </a:r>
          </a:p>
        </p:txBody>
      </p:sp>
    </p:spTree>
    <p:extLst>
      <p:ext uri="{BB962C8B-B14F-4D97-AF65-F5344CB8AC3E}">
        <p14:creationId xmlns:p14="http://schemas.microsoft.com/office/powerpoint/2010/main" val="24000180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">
            <a:extLst>
              <a:ext uri="{FF2B5EF4-FFF2-40B4-BE49-F238E27FC236}">
                <a16:creationId xmlns:a16="http://schemas.microsoft.com/office/drawing/2014/main" id="{98693C48-3949-416A-BA22-E1FF30AEAA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262312" y="728662"/>
            <a:ext cx="5667375" cy="540067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D296BE0-C0D0-444E-9E69-28B62791311A}"/>
              </a:ext>
            </a:extLst>
          </p:cNvPr>
          <p:cNvSpPr/>
          <p:nvPr/>
        </p:nvSpPr>
        <p:spPr>
          <a:xfrm>
            <a:off x="1945785" y="114635"/>
            <a:ext cx="7478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VCvsPM-H_PS3-IvsPM-H_PS3-IvsPM-I_PS3-IvsPS3-H_PS3-IvsVC novel miRNA</a:t>
            </a:r>
          </a:p>
        </p:txBody>
      </p:sp>
    </p:spTree>
    <p:extLst>
      <p:ext uri="{BB962C8B-B14F-4D97-AF65-F5344CB8AC3E}">
        <p14:creationId xmlns:p14="http://schemas.microsoft.com/office/powerpoint/2010/main" val="24328899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40A321A-F81F-435F-8C70-6BF73DFD02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300" y="1590675"/>
            <a:ext cx="5105400" cy="36766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852DCA3-7417-4C2C-9829-AB52B191748C}"/>
              </a:ext>
            </a:extLst>
          </p:cNvPr>
          <p:cNvSpPr txBox="1"/>
          <p:nvPr/>
        </p:nvSpPr>
        <p:spPr>
          <a:xfrm>
            <a:off x="1047502" y="744820"/>
            <a:ext cx="15683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Known miRN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8DB7347-3E2C-2B44-74FB-20190FCF5990}"/>
              </a:ext>
            </a:extLst>
          </p:cNvPr>
          <p:cNvSpPr txBox="1"/>
          <p:nvPr/>
        </p:nvSpPr>
        <p:spPr>
          <a:xfrm>
            <a:off x="2624325" y="1508141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5777072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49F377D5-9A3F-47A9-A990-417B121593EC}"/>
              </a:ext>
            </a:extLst>
          </p:cNvPr>
          <p:cNvGrpSpPr/>
          <p:nvPr/>
        </p:nvGrpSpPr>
        <p:grpSpPr>
          <a:xfrm>
            <a:off x="1779498" y="931671"/>
            <a:ext cx="7322940" cy="3937175"/>
            <a:chOff x="1779498" y="931671"/>
            <a:chExt cx="7322940" cy="3937175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38771493-A87A-4E61-95CD-614AA97D262A}"/>
                </a:ext>
              </a:extLst>
            </p:cNvPr>
            <p:cNvGrpSpPr/>
            <p:nvPr/>
          </p:nvGrpSpPr>
          <p:grpSpPr>
            <a:xfrm>
              <a:off x="2337846" y="931671"/>
              <a:ext cx="6764592" cy="3937175"/>
              <a:chOff x="1150989" y="719666"/>
              <a:chExt cx="8422265" cy="5418667"/>
            </a:xfrm>
          </p:grpSpPr>
          <p:graphicFrame>
            <p:nvGraphicFramePr>
              <p:cNvPr id="3" name="Diagram 2">
                <a:extLst>
                  <a:ext uri="{FF2B5EF4-FFF2-40B4-BE49-F238E27FC236}">
                    <a16:creationId xmlns:a16="http://schemas.microsoft.com/office/drawing/2014/main" id="{8ADDDA76-C82B-47D1-AC03-9816179CCBC5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117805986"/>
                  </p:ext>
                </p:extLst>
              </p:nvPr>
            </p:nvGraphicFramePr>
            <p:xfrm>
              <a:off x="2032000" y="719666"/>
              <a:ext cx="6565245" cy="5418667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2" r:lo="rId3" r:qs="rId4" r:cs="rId5"/>
              </a:graphicData>
            </a:graphic>
          </p:graphicFrame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D90F9738-90C7-4262-AE2F-DFB9ED4C7B8C}"/>
                  </a:ext>
                </a:extLst>
              </p:cNvPr>
              <p:cNvSpPr txBox="1"/>
              <p:nvPr/>
            </p:nvSpPr>
            <p:spPr>
              <a:xfrm>
                <a:off x="4694549" y="3167407"/>
                <a:ext cx="429500" cy="6565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2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031EB802-5F4C-4EEC-865A-24071B34772C}"/>
                  </a:ext>
                </a:extLst>
              </p:cNvPr>
              <p:cNvSpPr/>
              <p:nvPr/>
            </p:nvSpPr>
            <p:spPr>
              <a:xfrm>
                <a:off x="1150989" y="1154691"/>
                <a:ext cx="1970274" cy="50830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3-I vs PM-I</a:t>
                </a:r>
                <a:endPara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82F16F7D-081F-486F-8A0D-E3C7664A0863}"/>
                  </a:ext>
                </a:extLst>
              </p:cNvPr>
              <p:cNvSpPr/>
              <p:nvPr/>
            </p:nvSpPr>
            <p:spPr>
              <a:xfrm>
                <a:off x="7275665" y="4705488"/>
                <a:ext cx="2297589" cy="50830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3-H vs PM-H</a:t>
                </a:r>
                <a:r>
                  <a:rPr lang="en-GB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7311AA8-0B06-4E48-B266-6CFB11B7E328}"/>
                </a:ext>
              </a:extLst>
            </p:cNvPr>
            <p:cNvSpPr txBox="1"/>
            <p:nvPr/>
          </p:nvSpPr>
          <p:spPr>
            <a:xfrm>
              <a:off x="1779498" y="931671"/>
              <a:ext cx="4090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01208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5</TotalTime>
  <Words>168</Words>
  <Application>Microsoft Office PowerPoint</Application>
  <PresentationFormat>Widescreen</PresentationFormat>
  <Paragraphs>28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Supplementary Dat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 </dc:creator>
  <cp:lastModifiedBy>Basavaprabhu Patil</cp:lastModifiedBy>
  <cp:revision>48</cp:revision>
  <dcterms:created xsi:type="dcterms:W3CDTF">2020-04-01T08:59:02Z</dcterms:created>
  <dcterms:modified xsi:type="dcterms:W3CDTF">2024-06-12T04:01:24Z</dcterms:modified>
</cp:coreProperties>
</file>